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EFA85D-DAA4-406D-A6A8-329AC11A77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42BA3E-C7DC-4D59-A100-727B218D55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ED59B-8D6A-4F50-BABC-793272D3F1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115DD9-0E9B-4ECD-BE13-ED2C48D9C5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8B6DB-B9FD-4EBE-B252-C0464B0670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9F08A-05BC-42E0-8F71-A999E53BE3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0F4B6-25B1-4F63-B100-C133A23E5B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7CE4BF-F138-4605-8167-42E6385016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5BD949-1501-4A7C-9652-068C8CB449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8BD36-F6C8-4A74-B3D6-C1066B1969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5604E4-A04C-434E-AF3A-F0CEA38286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1F51CE-DCF7-45B9-82E4-F085ED12C2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95698C-FB9D-4D23-A881-9D04FE7F1E0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358920" y="198360"/>
            <a:ext cx="10823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2.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Unsupervised variable clustering to evaluate correlations between variables associated with primary outcomes among graduate students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image1.png" descr="A screenshot of a graph&#10;&#10;Description automatically generated with low confidence"/>
          <p:cNvPicPr/>
          <p:nvPr/>
        </p:nvPicPr>
        <p:blipFill>
          <a:blip r:embed="rId1"/>
          <a:stretch/>
        </p:blipFill>
        <p:spPr>
          <a:xfrm>
            <a:off x="4541760" y="493560"/>
            <a:ext cx="6640560" cy="636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5-30T19:36:09Z</dcterms:created>
  <dc:creator>Omar Toubat</dc:creator>
  <dc:description/>
  <dc:language>en-US</dc:language>
  <cp:lastModifiedBy>Toubat, Omar</cp:lastModifiedBy>
  <dcterms:modified xsi:type="dcterms:W3CDTF">2024-04-16T20:03:16Z</dcterms:modified>
  <cp:revision>56</cp:revision>
  <dc:subject/>
  <dc:title>PowerPoint Presentation</dc:title>
</cp:coreProperties>
</file>